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DC1A04-22DB-47FE-944F-71CCD85CE5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185D69-8D2A-4D6F-85C1-AFFCA82083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C1A4C3-DA8D-4312-827D-37DDCB2B55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B82ACB-A0FD-4A97-8E2B-BC9355520E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8D9E3C-B48A-4640-B42C-9E030C71B0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77D1E-9E2D-4F7A-AE97-4E75BBA4D2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C1C243-CD76-4271-99BC-B9AB09B498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EC294C-9721-47D5-9262-D34A630CD5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2B6D63-F596-4F41-93BB-EC3F548CCA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91862C-F4F1-458F-AE12-D755479FCC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88548A-4DB5-48CE-8E4F-B70C6760E3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9AF56A-DE58-46E9-8E39-6F718DB5D2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6826B6-2AA8-4541-9213-22A2B789A2A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C:\Documents and Settings\lab203 pc 1\Desktop\DUF paper work\Final dpi set figures\S 1.tif"/>
          <p:cNvPicPr/>
          <p:nvPr/>
        </p:nvPicPr>
        <p:blipFill>
          <a:blip r:embed="rId1"/>
          <a:stretch/>
        </p:blipFill>
        <p:spPr>
          <a:xfrm>
            <a:off x="1066680" y="380880"/>
            <a:ext cx="4343400" cy="4353120"/>
          </a:xfrm>
          <a:prstGeom prst="rect">
            <a:avLst/>
          </a:prstGeom>
          <a:ln w="0">
            <a:noFill/>
          </a:ln>
        </p:spPr>
      </p:pic>
      <p:sp>
        <p:nvSpPr>
          <p:cNvPr id="42" name="TextBox 2"/>
          <p:cNvSpPr/>
          <p:nvPr/>
        </p:nvSpPr>
        <p:spPr>
          <a:xfrm>
            <a:off x="1071720" y="4786200"/>
            <a:ext cx="4525920" cy="173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Relationship between the members of TRASH clan (CL0175)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individual members are arranged on the basis of signature motif similarity. Solid lines connect the closely related families with E value less than 10-3. Dashed lines connect the distantly related families with an E value between 10-3 and 10-1. The figure is adopted from PFAM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NIPGR</cp:lastModifiedBy>
  <dcterms:modified xsi:type="dcterms:W3CDTF">2014-05-13T07:26:47Z</dcterms:modified>
  <cp:revision>1</cp:revision>
  <dc:subject/>
  <dc:title>Slide 1</dc:title>
</cp:coreProperties>
</file>